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96" r:id="rId1"/>
  </p:sldMasterIdLst>
  <p:notesMasterIdLst>
    <p:notesMasterId r:id="rId4"/>
  </p:notesMasterIdLst>
  <p:sldIdLst>
    <p:sldId id="309" r:id="rId2"/>
    <p:sldId id="308" r:id="rId3"/>
  </p:sldIdLst>
  <p:sldSz cx="6480175" cy="10439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606" autoAdjust="0"/>
    <p:restoredTop sz="96716" autoAdjust="0"/>
  </p:normalViewPr>
  <p:slideViewPr>
    <p:cSldViewPr snapToGrid="0">
      <p:cViewPr>
        <p:scale>
          <a:sx n="125" d="100"/>
          <a:sy n="125" d="100"/>
        </p:scale>
        <p:origin x="1251" y="-3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65" d="100"/>
          <a:sy n="65" d="100"/>
        </p:scale>
        <p:origin x="3154" y="6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CCCF74-75D2-4712-94EC-0BC225B5E4FA}" type="datetimeFigureOut">
              <a:rPr lang="zh-CN" altLang="en-US" smtClean="0"/>
              <a:t>2023/11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471738" y="1143000"/>
            <a:ext cx="1914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05D2C5-49DA-412C-9711-A5A07285C2F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390601" rtl="0" eaLnBrk="1" latinLnBrk="0" hangingPunct="1">
      <a:defRPr sz="513" kern="1200">
        <a:solidFill>
          <a:schemeClr val="tx1"/>
        </a:solidFill>
        <a:latin typeface="+mn-lt"/>
        <a:ea typeface="+mn-ea"/>
        <a:cs typeface="+mn-cs"/>
      </a:defRPr>
    </a:lvl1pPr>
    <a:lvl2pPr marL="195301" algn="l" defTabSz="390601" rtl="0" eaLnBrk="1" latinLnBrk="0" hangingPunct="1">
      <a:defRPr sz="513" kern="1200">
        <a:solidFill>
          <a:schemeClr val="tx1"/>
        </a:solidFill>
        <a:latin typeface="+mn-lt"/>
        <a:ea typeface="+mn-ea"/>
        <a:cs typeface="+mn-cs"/>
      </a:defRPr>
    </a:lvl2pPr>
    <a:lvl3pPr marL="390601" algn="l" defTabSz="390601" rtl="0" eaLnBrk="1" latinLnBrk="0" hangingPunct="1">
      <a:defRPr sz="513" kern="1200">
        <a:solidFill>
          <a:schemeClr val="tx1"/>
        </a:solidFill>
        <a:latin typeface="+mn-lt"/>
        <a:ea typeface="+mn-ea"/>
        <a:cs typeface="+mn-cs"/>
      </a:defRPr>
    </a:lvl3pPr>
    <a:lvl4pPr marL="585717" algn="l" defTabSz="390601" rtl="0" eaLnBrk="1" latinLnBrk="0" hangingPunct="1">
      <a:defRPr sz="513" kern="1200">
        <a:solidFill>
          <a:schemeClr val="tx1"/>
        </a:solidFill>
        <a:latin typeface="+mn-lt"/>
        <a:ea typeface="+mn-ea"/>
        <a:cs typeface="+mn-cs"/>
      </a:defRPr>
    </a:lvl4pPr>
    <a:lvl5pPr marL="781017" algn="l" defTabSz="390601" rtl="0" eaLnBrk="1" latinLnBrk="0" hangingPunct="1">
      <a:defRPr sz="513" kern="1200">
        <a:solidFill>
          <a:schemeClr val="tx1"/>
        </a:solidFill>
        <a:latin typeface="+mn-lt"/>
        <a:ea typeface="+mn-ea"/>
        <a:cs typeface="+mn-cs"/>
      </a:defRPr>
    </a:lvl5pPr>
    <a:lvl6pPr marL="976319" algn="l" defTabSz="390601" rtl="0" eaLnBrk="1" latinLnBrk="0" hangingPunct="1">
      <a:defRPr sz="513" kern="1200">
        <a:solidFill>
          <a:schemeClr val="tx1"/>
        </a:solidFill>
        <a:latin typeface="+mn-lt"/>
        <a:ea typeface="+mn-ea"/>
        <a:cs typeface="+mn-cs"/>
      </a:defRPr>
    </a:lvl6pPr>
    <a:lvl7pPr marL="1171618" algn="l" defTabSz="390601" rtl="0" eaLnBrk="1" latinLnBrk="0" hangingPunct="1">
      <a:defRPr sz="513" kern="1200">
        <a:solidFill>
          <a:schemeClr val="tx1"/>
        </a:solidFill>
        <a:latin typeface="+mn-lt"/>
        <a:ea typeface="+mn-ea"/>
        <a:cs typeface="+mn-cs"/>
      </a:defRPr>
    </a:lvl7pPr>
    <a:lvl8pPr marL="1366919" algn="l" defTabSz="390601" rtl="0" eaLnBrk="1" latinLnBrk="0" hangingPunct="1">
      <a:defRPr sz="513" kern="1200">
        <a:solidFill>
          <a:schemeClr val="tx1"/>
        </a:solidFill>
        <a:latin typeface="+mn-lt"/>
        <a:ea typeface="+mn-ea"/>
        <a:cs typeface="+mn-cs"/>
      </a:defRPr>
    </a:lvl8pPr>
    <a:lvl9pPr marL="1562035" algn="l" defTabSz="390601" rtl="0" eaLnBrk="1" latinLnBrk="0" hangingPunct="1">
      <a:defRPr sz="51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708486"/>
            <a:ext cx="5508149" cy="3634458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5483102"/>
            <a:ext cx="4860131" cy="2520438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4A46F-A876-4C90-80B5-ED1CCE25090B}" type="datetimeFigureOut">
              <a:rPr lang="zh-CN" altLang="en-US" smtClean="0"/>
              <a:t>2023/1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88F48-480F-481A-AB4D-297C17DFFF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1169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4A46F-A876-4C90-80B5-ED1CCE25090B}" type="datetimeFigureOut">
              <a:rPr lang="zh-CN" altLang="en-US" smtClean="0"/>
              <a:t>2023/1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88F48-480F-481A-AB4D-297C17DFFF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6234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555801"/>
            <a:ext cx="1397288" cy="884690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555801"/>
            <a:ext cx="4110861" cy="884690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4A46F-A876-4C90-80B5-ED1CCE25090B}" type="datetimeFigureOut">
              <a:rPr lang="zh-CN" altLang="en-US" smtClean="0"/>
              <a:t>2023/1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88F48-480F-481A-AB4D-297C17DFFF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5738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4A46F-A876-4C90-80B5-ED1CCE25090B}" type="datetimeFigureOut">
              <a:rPr lang="zh-CN" altLang="en-US" smtClean="0"/>
              <a:t>2023/1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88F48-480F-481A-AB4D-297C17DFFF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2431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602603"/>
            <a:ext cx="5589151" cy="4342500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986185"/>
            <a:ext cx="5589151" cy="2283618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4A46F-A876-4C90-80B5-ED1CCE25090B}" type="datetimeFigureOut">
              <a:rPr lang="zh-CN" altLang="en-US" smtClean="0"/>
              <a:t>2023/1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88F48-480F-481A-AB4D-297C17DFFF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587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779007"/>
            <a:ext cx="2754074" cy="66237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779007"/>
            <a:ext cx="2754074" cy="66237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4A46F-A876-4C90-80B5-ED1CCE25090B}" type="datetimeFigureOut">
              <a:rPr lang="zh-CN" altLang="en-US" smtClean="0"/>
              <a:t>2023/11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88F48-480F-481A-AB4D-297C17DFFF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630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55804"/>
            <a:ext cx="5589151" cy="201780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559104"/>
            <a:ext cx="2741417" cy="1254177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813281"/>
            <a:ext cx="2741417" cy="560876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559104"/>
            <a:ext cx="2754918" cy="1254177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813281"/>
            <a:ext cx="2754918" cy="560876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4A46F-A876-4C90-80B5-ED1CCE25090B}" type="datetimeFigureOut">
              <a:rPr lang="zh-CN" altLang="en-US" smtClean="0"/>
              <a:t>2023/11/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88F48-480F-481A-AB4D-297C17DFFF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2103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4A46F-A876-4C90-80B5-ED1CCE25090B}" type="datetimeFigureOut">
              <a:rPr lang="zh-CN" altLang="en-US" smtClean="0"/>
              <a:t>2023/11/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88F48-480F-481A-AB4D-297C17DFFF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4015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4A46F-A876-4C90-80B5-ED1CCE25090B}" type="datetimeFigureOut">
              <a:rPr lang="zh-CN" altLang="en-US" smtClean="0"/>
              <a:t>2023/11/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88F48-480F-481A-AB4D-297C17DFFF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96369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95960"/>
            <a:ext cx="2090025" cy="243586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503083"/>
            <a:ext cx="3280589" cy="7418740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3131820"/>
            <a:ext cx="2090025" cy="5802084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4A46F-A876-4C90-80B5-ED1CCE25090B}" type="datetimeFigureOut">
              <a:rPr lang="zh-CN" altLang="en-US" smtClean="0"/>
              <a:t>2023/11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88F48-480F-481A-AB4D-297C17DFFF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2422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95960"/>
            <a:ext cx="2090025" cy="243586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503083"/>
            <a:ext cx="3280589" cy="7418740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3131820"/>
            <a:ext cx="2090025" cy="5802084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4A46F-A876-4C90-80B5-ED1CCE25090B}" type="datetimeFigureOut">
              <a:rPr lang="zh-CN" altLang="en-US" smtClean="0"/>
              <a:t>2023/11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88F48-480F-481A-AB4D-297C17DFFF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254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555804"/>
            <a:ext cx="5589151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779007"/>
            <a:ext cx="5589151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9675780"/>
            <a:ext cx="1458039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64A46F-A876-4C90-80B5-ED1CCE25090B}" type="datetimeFigureOut">
              <a:rPr lang="zh-CN" altLang="en-US" smtClean="0"/>
              <a:t>2023/1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9675780"/>
            <a:ext cx="2187059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9675780"/>
            <a:ext cx="1458039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A88F48-480F-481A-AB4D-297C17DFFF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5745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91201CF5-7F6E-7CBE-FEA2-AF2E97DDF94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019" y="615893"/>
            <a:ext cx="5937504" cy="529437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773104DD-9C9A-3D43-86E6-0EF5A801700B}"/>
              </a:ext>
            </a:extLst>
          </p:cNvPr>
          <p:cNvSpPr txBox="1"/>
          <p:nvPr/>
        </p:nvSpPr>
        <p:spPr>
          <a:xfrm>
            <a:off x="48677" y="6646550"/>
            <a:ext cx="6382819" cy="11440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</a:t>
            </a:r>
            <a:r>
              <a:rPr lang="en-US" altLang="zh-CN" sz="1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 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correlation between the copy number of the gene 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ur3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SA/V ratio of collected ammonia oxidizing archaea (AOA; correlation coefficient R=0.754, 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=0.003; Spearman Rank Correlation).</a:t>
            </a:r>
            <a:endParaRPr lang="zh-CN" altLang="zh-CN" sz="12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04485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90F29435-D998-D766-4428-1F9D47E421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55" y="772160"/>
            <a:ext cx="6382819" cy="5630550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ED242990-21C7-8D8F-6755-942904735297}"/>
              </a:ext>
            </a:extLst>
          </p:cNvPr>
          <p:cNvSpPr txBox="1"/>
          <p:nvPr/>
        </p:nvSpPr>
        <p:spPr>
          <a:xfrm>
            <a:off x="48677" y="6646550"/>
            <a:ext cx="6382819" cy="22560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2</a:t>
            </a:r>
            <a:r>
              <a:rPr lang="en-US" altLang="zh-CN" sz="1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 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hylogenetic tree of amino acid fragments</a:t>
            </a:r>
            <a:r>
              <a:rPr lang="en-US" altLang="zh-CN" sz="12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of </a:t>
            </a:r>
            <a:r>
              <a:rPr lang="en-US" altLang="zh-CN" sz="12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peA</a:t>
            </a:r>
            <a:r>
              <a:rPr lang="en-US" altLang="zh-CN" sz="12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identified from ammonia-oxidizing archaea (AOA) and bacteria (AOB), nitrite-oxidizing bacteria (NOB) and complete ammonia oxidizers (</a:t>
            </a:r>
            <a:r>
              <a:rPr lang="en-US" altLang="zh-CN" sz="12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omammox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). The tree is constructed with the Maximum Likelihood method. Bootstrap values based on 1000 replicates are indicated for the major branches and the values &gt;50 are showed as black dots. The numbers in brackets indicate the second copy of </a:t>
            </a:r>
            <a:r>
              <a:rPr lang="en-US" altLang="zh-CN" sz="12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peA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from the same strain. The strains highlighted in bold represent marine origin.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5617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8035</TotalTime>
  <Words>130</Words>
  <Application>Microsoft Office PowerPoint</Application>
  <PresentationFormat>自定义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 yuhao</dc:creator>
  <cp:lastModifiedBy>Qian Liu</cp:lastModifiedBy>
  <cp:revision>280</cp:revision>
  <dcterms:created xsi:type="dcterms:W3CDTF">2021-10-13T05:22:00Z</dcterms:created>
  <dcterms:modified xsi:type="dcterms:W3CDTF">2023-11-24T22:39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E1EE7D6306024876AC0295E009658253</vt:lpwstr>
  </property>
  <property fmtid="{D5CDD505-2E9C-101B-9397-08002B2CF9AE}" pid="3" name="KSOProductBuildVer">
    <vt:lpwstr>2052-11.1.0.11115</vt:lpwstr>
  </property>
</Properties>
</file>